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8000345" cy="1800034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654" userDrawn="1">
          <p15:clr>
            <a:srgbClr val="A4A3A4"/>
          </p15:clr>
        </p15:guide>
        <p15:guide id="2" pos="567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9" d="100"/>
          <a:sy n="59" d="100"/>
        </p:scale>
        <p:origin x="3112" y="116"/>
      </p:cViewPr>
      <p:guideLst>
        <p:guide orient="horz" pos="5654"/>
        <p:guide pos="567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945943"/>
            <a:ext cx="15300564" cy="6266897"/>
          </a:xfrm>
        </p:spPr>
        <p:txBody>
          <a:bodyPr anchor="b"/>
          <a:lstStyle>
            <a:lvl1pPr algn="ctr">
              <a:defRPr sz="118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9454516"/>
            <a:ext cx="13500497" cy="4345992"/>
          </a:xfrm>
        </p:spPr>
        <p:txBody>
          <a:bodyPr/>
          <a:lstStyle>
            <a:lvl1pPr marL="0" indent="0" algn="ctr">
              <a:buNone/>
              <a:defRPr sz="4725"/>
            </a:lvl1pPr>
            <a:lvl2pPr marL="899795" indent="0" algn="ctr">
              <a:buNone/>
              <a:defRPr sz="3935"/>
            </a:lvl2pPr>
            <a:lvl3pPr marL="1800225" indent="0" algn="ctr">
              <a:buNone/>
              <a:defRPr sz="3545"/>
            </a:lvl3pPr>
            <a:lvl4pPr marL="2700020" indent="0" algn="ctr">
              <a:buNone/>
              <a:defRPr sz="3150"/>
            </a:lvl4pPr>
            <a:lvl5pPr marL="3600450" indent="0" algn="ctr">
              <a:buNone/>
              <a:defRPr sz="3150"/>
            </a:lvl5pPr>
            <a:lvl6pPr marL="4500245" indent="0" algn="ctr">
              <a:buNone/>
              <a:defRPr sz="3150"/>
            </a:lvl6pPr>
            <a:lvl7pPr marL="5400040" indent="0" algn="ctr">
              <a:buNone/>
              <a:defRPr sz="3150"/>
            </a:lvl7pPr>
            <a:lvl8pPr marL="6300470" indent="0" algn="ctr">
              <a:buNone/>
              <a:defRPr sz="3150"/>
            </a:lvl8pPr>
            <a:lvl9pPr marL="7200265" indent="0" algn="ctr">
              <a:buNone/>
              <a:defRPr sz="315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958369"/>
            <a:ext cx="3881393" cy="1525473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958369"/>
            <a:ext cx="11419171" cy="1525473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4487671"/>
            <a:ext cx="15525572" cy="7487774"/>
          </a:xfrm>
        </p:spPr>
        <p:txBody>
          <a:bodyPr anchor="b"/>
          <a:lstStyle>
            <a:lvl1pPr>
              <a:defRPr sz="1181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2046282"/>
            <a:ext cx="15525572" cy="3937644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899795" indent="0">
              <a:buNone/>
              <a:defRPr sz="3935">
                <a:solidFill>
                  <a:schemeClr val="tx1">
                    <a:tint val="75000"/>
                  </a:schemeClr>
                </a:solidFill>
              </a:defRPr>
            </a:lvl2pPr>
            <a:lvl3pPr marL="1800225" indent="0">
              <a:buNone/>
              <a:defRPr sz="3545">
                <a:solidFill>
                  <a:schemeClr val="tx1">
                    <a:tint val="75000"/>
                  </a:schemeClr>
                </a:solidFill>
              </a:defRPr>
            </a:lvl3pPr>
            <a:lvl4pPr marL="27000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45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4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04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47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265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4791843"/>
            <a:ext cx="7650282" cy="1142125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58373"/>
            <a:ext cx="15525572" cy="347929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4412664"/>
            <a:ext cx="7615123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899795" indent="0">
              <a:buNone/>
              <a:defRPr sz="3935" b="1"/>
            </a:lvl2pPr>
            <a:lvl3pPr marL="1800225" indent="0">
              <a:buNone/>
              <a:defRPr sz="3545" b="1"/>
            </a:lvl3pPr>
            <a:lvl4pPr marL="2700020" indent="0">
              <a:buNone/>
              <a:defRPr sz="3150" b="1"/>
            </a:lvl4pPr>
            <a:lvl5pPr marL="3600450" indent="0">
              <a:buNone/>
              <a:defRPr sz="3150" b="1"/>
            </a:lvl5pPr>
            <a:lvl6pPr marL="4500245" indent="0">
              <a:buNone/>
              <a:defRPr sz="3150" b="1"/>
            </a:lvl6pPr>
            <a:lvl7pPr marL="5400040" indent="0">
              <a:buNone/>
              <a:defRPr sz="3150" b="1"/>
            </a:lvl7pPr>
            <a:lvl8pPr marL="6300470" indent="0">
              <a:buNone/>
              <a:defRPr sz="3150" b="1"/>
            </a:lvl8pPr>
            <a:lvl9pPr marL="7200265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6575242"/>
            <a:ext cx="7615123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4412664"/>
            <a:ext cx="7652626" cy="2162578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899795" indent="0">
              <a:buNone/>
              <a:defRPr sz="3935" b="1"/>
            </a:lvl2pPr>
            <a:lvl3pPr marL="1800225" indent="0">
              <a:buNone/>
              <a:defRPr sz="3545" b="1"/>
            </a:lvl3pPr>
            <a:lvl4pPr marL="2700020" indent="0">
              <a:buNone/>
              <a:defRPr sz="3150" b="1"/>
            </a:lvl4pPr>
            <a:lvl5pPr marL="3600450" indent="0">
              <a:buNone/>
              <a:defRPr sz="3150" b="1"/>
            </a:lvl5pPr>
            <a:lvl6pPr marL="4500245" indent="0">
              <a:buNone/>
              <a:defRPr sz="3150" b="1"/>
            </a:lvl6pPr>
            <a:lvl7pPr marL="5400040" indent="0">
              <a:buNone/>
              <a:defRPr sz="3150" b="1"/>
            </a:lvl7pPr>
            <a:lvl8pPr marL="6300470" indent="0">
              <a:buNone/>
              <a:defRPr sz="3150" b="1"/>
            </a:lvl8pPr>
            <a:lvl9pPr marL="7200265" indent="0">
              <a:buNone/>
              <a:defRPr sz="315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6575242"/>
            <a:ext cx="7652626" cy="967119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591766"/>
            <a:ext cx="9112836" cy="12792138"/>
          </a:xfrm>
        </p:spPr>
        <p:txBody>
          <a:bodyPr/>
          <a:lstStyle>
            <a:lvl1pPr>
              <a:defRPr sz="6300"/>
            </a:lvl1pPr>
            <a:lvl2pPr>
              <a:defRPr sz="5510"/>
            </a:lvl2pPr>
            <a:lvl3pPr>
              <a:defRPr sz="4725"/>
            </a:lvl3pPr>
            <a:lvl4pPr>
              <a:defRPr sz="3935"/>
            </a:lvl4pPr>
            <a:lvl5pPr>
              <a:defRPr sz="3935"/>
            </a:lvl5pPr>
            <a:lvl6pPr>
              <a:defRPr sz="3935"/>
            </a:lvl6pPr>
            <a:lvl7pPr>
              <a:defRPr sz="3935"/>
            </a:lvl7pPr>
            <a:lvl8pPr>
              <a:defRPr sz="3935"/>
            </a:lvl8pPr>
            <a:lvl9pPr>
              <a:defRPr sz="3935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899795" indent="0">
              <a:buNone/>
              <a:defRPr sz="2755"/>
            </a:lvl2pPr>
            <a:lvl3pPr marL="1800225" indent="0">
              <a:buNone/>
              <a:defRPr sz="2360"/>
            </a:lvl3pPr>
            <a:lvl4pPr marL="2700020" indent="0">
              <a:buNone/>
              <a:defRPr sz="1970"/>
            </a:lvl4pPr>
            <a:lvl5pPr marL="3600450" indent="0">
              <a:buNone/>
              <a:defRPr sz="1970"/>
            </a:lvl5pPr>
            <a:lvl6pPr marL="4500245" indent="0">
              <a:buNone/>
              <a:defRPr sz="1970"/>
            </a:lvl6pPr>
            <a:lvl7pPr marL="5400040" indent="0">
              <a:buNone/>
              <a:defRPr sz="1970"/>
            </a:lvl7pPr>
            <a:lvl8pPr marL="6300470" indent="0">
              <a:buNone/>
              <a:defRPr sz="1970"/>
            </a:lvl8pPr>
            <a:lvl9pPr marL="7200265" indent="0">
              <a:buNone/>
              <a:defRPr sz="197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200044"/>
            <a:ext cx="5805682" cy="420015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591766"/>
            <a:ext cx="9112836" cy="12792138"/>
          </a:xfrm>
        </p:spPr>
        <p:txBody>
          <a:bodyPr anchor="t"/>
          <a:lstStyle>
            <a:lvl1pPr marL="0" indent="0">
              <a:buNone/>
              <a:defRPr sz="6300"/>
            </a:lvl1pPr>
            <a:lvl2pPr marL="899795" indent="0">
              <a:buNone/>
              <a:defRPr sz="5510"/>
            </a:lvl2pPr>
            <a:lvl3pPr marL="1800225" indent="0">
              <a:buNone/>
              <a:defRPr sz="4725"/>
            </a:lvl3pPr>
            <a:lvl4pPr marL="2700020" indent="0">
              <a:buNone/>
              <a:defRPr sz="3935"/>
            </a:lvl4pPr>
            <a:lvl5pPr marL="3600450" indent="0">
              <a:buNone/>
              <a:defRPr sz="3935"/>
            </a:lvl5pPr>
            <a:lvl6pPr marL="4500245" indent="0">
              <a:buNone/>
              <a:defRPr sz="3935"/>
            </a:lvl6pPr>
            <a:lvl7pPr marL="5400040" indent="0">
              <a:buNone/>
              <a:defRPr sz="3935"/>
            </a:lvl7pPr>
            <a:lvl8pPr marL="6300470" indent="0">
              <a:buNone/>
              <a:defRPr sz="3935"/>
            </a:lvl8pPr>
            <a:lvl9pPr marL="7200265" indent="0">
              <a:buNone/>
              <a:defRPr sz="393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5400199"/>
            <a:ext cx="5805682" cy="10004536"/>
          </a:xfrm>
        </p:spPr>
        <p:txBody>
          <a:bodyPr/>
          <a:lstStyle>
            <a:lvl1pPr marL="0" indent="0">
              <a:buNone/>
              <a:defRPr sz="3150"/>
            </a:lvl1pPr>
            <a:lvl2pPr marL="899795" indent="0">
              <a:buNone/>
              <a:defRPr sz="2755"/>
            </a:lvl2pPr>
            <a:lvl3pPr marL="1800225" indent="0">
              <a:buNone/>
              <a:defRPr sz="2360"/>
            </a:lvl3pPr>
            <a:lvl4pPr marL="2700020" indent="0">
              <a:buNone/>
              <a:defRPr sz="1970"/>
            </a:lvl4pPr>
            <a:lvl5pPr marL="3600450" indent="0">
              <a:buNone/>
              <a:defRPr sz="1970"/>
            </a:lvl5pPr>
            <a:lvl6pPr marL="4500245" indent="0">
              <a:buNone/>
              <a:defRPr sz="1970"/>
            </a:lvl6pPr>
            <a:lvl7pPr marL="5400040" indent="0">
              <a:buNone/>
              <a:defRPr sz="1970"/>
            </a:lvl7pPr>
            <a:lvl8pPr marL="6300470" indent="0">
              <a:buNone/>
              <a:defRPr sz="1970"/>
            </a:lvl8pPr>
            <a:lvl9pPr marL="7200265" indent="0">
              <a:buNone/>
              <a:defRPr sz="197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958373"/>
            <a:ext cx="15525572" cy="347929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4791843"/>
            <a:ext cx="15525572" cy="1142125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55E9E8-51A8-4BD6-A20F-7EE41936A298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6683952"/>
            <a:ext cx="6075224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6683952"/>
            <a:ext cx="4050149" cy="95836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8CD480-C468-4556-BFDD-E888C9FBB5B8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800225" rtl="0" eaLnBrk="1" latinLnBrk="0" hangingPunct="1">
        <a:lnSpc>
          <a:spcPct val="90000"/>
        </a:lnSpc>
        <a:spcBef>
          <a:spcPct val="0"/>
        </a:spcBef>
        <a:buNone/>
        <a:defRPr sz="866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215" indent="-450215" algn="l" defTabSz="1800225" rtl="0" eaLnBrk="1" latinLnBrk="0" hangingPunct="1">
        <a:lnSpc>
          <a:spcPct val="90000"/>
        </a:lnSpc>
        <a:spcBef>
          <a:spcPts val="1970"/>
        </a:spcBef>
        <a:buFont typeface="Arial" panose="020B0604020202020204" pitchFamily="34" charset="0"/>
        <a:buChar char="•"/>
        <a:defRPr sz="5510" kern="1200">
          <a:solidFill>
            <a:schemeClr val="tx1"/>
          </a:solidFill>
          <a:latin typeface="+mn-lt"/>
          <a:ea typeface="+mn-ea"/>
          <a:cs typeface="+mn-cs"/>
        </a:defRPr>
      </a:lvl1pPr>
      <a:lvl2pPr marL="135001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4980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935" kern="1200">
          <a:solidFill>
            <a:schemeClr val="tx1"/>
          </a:solidFill>
          <a:latin typeface="+mn-lt"/>
          <a:ea typeface="+mn-ea"/>
          <a:cs typeface="+mn-cs"/>
        </a:defRPr>
      </a:lvl3pPr>
      <a:lvl4pPr marL="315023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405003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95046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850255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75005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650480" indent="-450215" algn="l" defTabSz="1800225" rtl="0" eaLnBrk="1" latinLnBrk="0" hangingPunct="1">
        <a:lnSpc>
          <a:spcPct val="90000"/>
        </a:lnSpc>
        <a:spcBef>
          <a:spcPts val="985"/>
        </a:spcBef>
        <a:buFont typeface="Arial" panose="020B0604020202020204" pitchFamily="34" charset="0"/>
        <a:buChar char="•"/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1pPr>
      <a:lvl2pPr marL="89979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2pPr>
      <a:lvl3pPr marL="180022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3pPr>
      <a:lvl4pPr marL="270002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4pPr>
      <a:lvl5pPr marL="360045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5pPr>
      <a:lvl6pPr marL="450024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6pPr>
      <a:lvl7pPr marL="540004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7pPr>
      <a:lvl8pPr marL="6300470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8pPr>
      <a:lvl9pPr marL="7200265" algn="l" defTabSz="1800225" rtl="0" eaLnBrk="1" latinLnBrk="0" hangingPunct="1">
        <a:defRPr sz="354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.xml"/><Relationship Id="rId5" Type="http://schemas.openxmlformats.org/officeDocument/2006/relationships/image" Target="../media/image5.jpeg"/><Relationship Id="rId4" Type="http://schemas.openxmlformats.org/officeDocument/2006/relationships/image" Target="../media/image4.png"/><Relationship Id="rId3" Type="http://schemas.openxmlformats.org/officeDocument/2006/relationships/image" Target="../media/image3.jpeg"/><Relationship Id="rId2" Type="http://schemas.openxmlformats.org/officeDocument/2006/relationships/image" Target="../media/image2.tiff"/><Relationship Id="rId1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图片 20" descr="RbCL"/>
          <p:cNvPicPr>
            <a:picLocks noChangeAspect="1"/>
          </p:cNvPicPr>
          <p:nvPr/>
        </p:nvPicPr>
        <p:blipFill>
          <a:blip r:embed="rId1"/>
          <a:srcRect l="8929" t="28689" r="3570" b="33299"/>
          <a:stretch>
            <a:fillRect/>
          </a:stretch>
        </p:blipFill>
        <p:spPr>
          <a:xfrm rot="10800000">
            <a:off x="4164965" y="10018395"/>
            <a:ext cx="6587490" cy="2146300"/>
          </a:xfrm>
          <a:prstGeom prst="rect">
            <a:avLst/>
          </a:prstGeom>
        </p:spPr>
      </p:pic>
      <p:pic>
        <p:nvPicPr>
          <p:cNvPr id="20" name="图片 19" descr="α-myc-blot"/>
          <p:cNvPicPr>
            <a:picLocks noChangeAspect="1"/>
          </p:cNvPicPr>
          <p:nvPr/>
        </p:nvPicPr>
        <p:blipFill>
          <a:blip r:embed="rId2"/>
          <a:srcRect l="12756" t="39600" b="40685"/>
          <a:stretch>
            <a:fillRect/>
          </a:stretch>
        </p:blipFill>
        <p:spPr>
          <a:xfrm>
            <a:off x="2832100" y="2827655"/>
            <a:ext cx="5760000" cy="1789719"/>
          </a:xfrm>
          <a:prstGeom prst="rect">
            <a:avLst/>
          </a:prstGeom>
        </p:spPr>
      </p:pic>
      <p:sp>
        <p:nvSpPr>
          <p:cNvPr id="17" name="文本框 16"/>
          <p:cNvSpPr txBox="1"/>
          <p:nvPr/>
        </p:nvSpPr>
        <p:spPr>
          <a:xfrm>
            <a:off x="1452212" y="13336442"/>
            <a:ext cx="14386626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800" dirty="0">
                <a:latin typeface="Arial" panose="020B0604020202020204" pitchFamily="34" charset="0"/>
                <a:cs typeface="Arial" panose="020B0604020202020204" pitchFamily="34" charset="0"/>
              </a:rPr>
              <a:t>Figure 4—figure supplement 7—source data 1. PowerPoint file containing original western blots for Figure 4—figure supplement 7, indicating the relevant bands and treatments</a:t>
            </a:r>
            <a:endParaRPr lang="zh-CN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832100" y="3025140"/>
            <a:ext cx="5760085" cy="976630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0"/>
          </a:p>
        </p:txBody>
      </p:sp>
      <p:sp>
        <p:nvSpPr>
          <p:cNvPr id="9" name="矩形 8"/>
          <p:cNvSpPr/>
          <p:nvPr/>
        </p:nvSpPr>
        <p:spPr>
          <a:xfrm>
            <a:off x="4904740" y="10475595"/>
            <a:ext cx="5697855" cy="821690"/>
          </a:xfrm>
          <a:prstGeom prst="rect">
            <a:avLst/>
          </a:prstGeom>
          <a:noFill/>
          <a:ln w="730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800"/>
          </a:p>
        </p:txBody>
      </p:sp>
      <p:grpSp>
        <p:nvGrpSpPr>
          <p:cNvPr id="10" name="组合 9"/>
          <p:cNvGrpSpPr/>
          <p:nvPr/>
        </p:nvGrpSpPr>
        <p:grpSpPr>
          <a:xfrm>
            <a:off x="10149674" y="3025426"/>
            <a:ext cx="6272600" cy="3466138"/>
            <a:chOff x="21059362" y="35879581"/>
            <a:chExt cx="11986753" cy="5810048"/>
          </a:xfrm>
        </p:grpSpPr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059362" y="35879581"/>
              <a:ext cx="11986751" cy="5810048"/>
            </a:xfrm>
            <a:prstGeom prst="rect">
              <a:avLst/>
            </a:prstGeom>
          </p:spPr>
        </p:pic>
        <p:sp>
          <p:nvSpPr>
            <p:cNvPr id="12" name="矩形 11"/>
            <p:cNvSpPr/>
            <p:nvPr/>
          </p:nvSpPr>
          <p:spPr>
            <a:xfrm>
              <a:off x="22211129" y="37826928"/>
              <a:ext cx="10834986" cy="2001793"/>
            </a:xfrm>
            <a:prstGeom prst="rect">
              <a:avLst/>
            </a:prstGeom>
            <a:noFill/>
            <a:ln w="730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sz="1800"/>
            </a:p>
          </p:txBody>
        </p:sp>
      </p:grpSp>
      <p:pic>
        <p:nvPicPr>
          <p:cNvPr id="13" name="图片 1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21228" y="1164773"/>
            <a:ext cx="7322875" cy="1566164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069488" y="1205068"/>
            <a:ext cx="7322875" cy="1566164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79662" y="8193571"/>
            <a:ext cx="7322875" cy="1566164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>
            <a:off x="4487575" y="6277779"/>
            <a:ext cx="2089416" cy="536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myc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12874089" y="6546192"/>
            <a:ext cx="2089416" cy="536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CCB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7104110" y="12159084"/>
            <a:ext cx="2089416" cy="5368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4800" dirty="0">
                <a:latin typeface="Arial" panose="020B0604020202020204" pitchFamily="34" charset="0"/>
                <a:cs typeface="Arial" panose="020B0604020202020204" pitchFamily="34" charset="0"/>
              </a:rPr>
              <a:t>RbcL</a:t>
            </a:r>
            <a:endParaRPr lang="zh-CN" altLang="en-US" sz="4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 descr="α-myc-marker"/>
          <p:cNvPicPr>
            <a:picLocks noChangeAspect="1"/>
          </p:cNvPicPr>
          <p:nvPr/>
        </p:nvPicPr>
        <p:blipFill>
          <a:blip r:embed="rId5"/>
          <a:srcRect t="36813" r="83390" b="41041"/>
          <a:stretch>
            <a:fillRect/>
          </a:stretch>
        </p:blipFill>
        <p:spPr>
          <a:xfrm>
            <a:off x="1856105" y="2754630"/>
            <a:ext cx="975927" cy="17892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4</Words>
  <Application>WPS 演示</Application>
  <PresentationFormat>自定义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Calibri</vt:lpstr>
      <vt:lpstr>微软雅黑</vt:lpstr>
      <vt:lpstr>Arial Unicode MS</vt:lpstr>
      <vt:lpstr>等线 Light</vt:lpstr>
      <vt:lpstr>Calibri Light</vt:lpstr>
      <vt:lpstr>等线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JHuang</dc:creator>
  <cp:lastModifiedBy>王鑫</cp:lastModifiedBy>
  <cp:revision>5</cp:revision>
  <dcterms:created xsi:type="dcterms:W3CDTF">2026-03-26T06:05:00Z</dcterms:created>
  <dcterms:modified xsi:type="dcterms:W3CDTF">2026-03-27T08:39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5225</vt:lpwstr>
  </property>
  <property fmtid="{D5CDD505-2E9C-101B-9397-08002B2CF9AE}" pid="3" name="ICV">
    <vt:lpwstr>CE5F948A723D45D79ED1C1B4F6148FCA_12</vt:lpwstr>
  </property>
</Properties>
</file>